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handoutMasterIdLst>
    <p:handoutMasterId r:id="rId3"/>
  </p:handout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58" d="100"/>
          <a:sy n="58" d="100"/>
        </p:scale>
        <p:origin x="101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84614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C9AD10-ADB4-4761-B901-DCAE11E18FD6}" type="datetimeFigureOut">
              <a:rPr lang="da-DK" smtClean="0"/>
              <a:t>12-01-2022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84614" y="8685214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9E9A62-9A85-437C-BC9D-C83A781B569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263396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2/0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Detection of </a:t>
            </a:r>
            <a:r>
              <a:rPr lang="en-GB" sz="2800" b="1" i="1" dirty="0">
                <a:solidFill>
                  <a:schemeClr val="bg1"/>
                </a:solidFill>
              </a:rPr>
              <a:t>DZIP1L</a:t>
            </a:r>
            <a:r>
              <a:rPr lang="en-GB" sz="2800" b="1" dirty="0">
                <a:solidFill>
                  <a:schemeClr val="bg1"/>
                </a:solidFill>
              </a:rPr>
              <a:t> mutations by whole exome sequencing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in consanguineous families with polycystic kidney diseas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i="1" dirty="0">
                <a:solidFill>
                  <a:schemeClr val="bg1"/>
                </a:solidFill>
              </a:rPr>
              <a:t>DZIP1L</a:t>
            </a:r>
            <a:r>
              <a:rPr lang="en-GB" dirty="0">
                <a:solidFill>
                  <a:schemeClr val="bg1"/>
                </a:solidFill>
              </a:rPr>
              <a:t> related ARPKD is rare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80183" y="1756048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We detected two new homozygous </a:t>
            </a:r>
            <a:r>
              <a:rPr lang="en-GB" i="1" dirty="0">
                <a:solidFill>
                  <a:srgbClr val="0065AA"/>
                </a:solidFill>
              </a:rPr>
              <a:t>DZIP1L</a:t>
            </a:r>
            <a:r>
              <a:rPr lang="en-GB" dirty="0">
                <a:solidFill>
                  <a:srgbClr val="0065AA"/>
                </a:solidFill>
              </a:rPr>
              <a:t> sequence variants in patients with ARPKD.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ertz et al.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2347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i="1" dirty="0">
                <a:solidFill>
                  <a:schemeClr val="bg1"/>
                </a:solidFill>
              </a:rPr>
              <a:t>DZIP1L</a:t>
            </a:r>
            <a:r>
              <a:rPr lang="en-GB" dirty="0">
                <a:solidFill>
                  <a:schemeClr val="bg1"/>
                </a:solidFill>
              </a:rPr>
              <a:t> related ARPKD is rare; only six different </a:t>
            </a:r>
            <a:r>
              <a:rPr lang="en-GB" i="1" dirty="0">
                <a:solidFill>
                  <a:schemeClr val="bg1"/>
                </a:solidFill>
              </a:rPr>
              <a:t>DZIP1L</a:t>
            </a:r>
            <a:r>
              <a:rPr lang="en-GB" dirty="0">
                <a:solidFill>
                  <a:schemeClr val="bg1"/>
                </a:solidFill>
              </a:rPr>
              <a:t> sequence variants have been reported to date, and liver involvement is not part of the phenotype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graphicFrame>
        <p:nvGraphicFramePr>
          <p:cNvPr id="2" name="Tabel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7259249"/>
              </p:ext>
            </p:extLst>
          </p:nvPr>
        </p:nvGraphicFramePr>
        <p:xfrm>
          <a:off x="1026810" y="2337447"/>
          <a:ext cx="10138380" cy="290830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92075">
                  <a:extLst>
                    <a:ext uri="{9D8B030D-6E8A-4147-A177-3AD203B41FA5}">
                      <a16:colId xmlns:a16="http://schemas.microsoft.com/office/drawing/2014/main" val="686232753"/>
                    </a:ext>
                  </a:extLst>
                </a:gridCol>
                <a:gridCol w="1973412">
                  <a:extLst>
                    <a:ext uri="{9D8B030D-6E8A-4147-A177-3AD203B41FA5}">
                      <a16:colId xmlns:a16="http://schemas.microsoft.com/office/drawing/2014/main" val="561186894"/>
                    </a:ext>
                  </a:extLst>
                </a:gridCol>
                <a:gridCol w="1490903">
                  <a:extLst>
                    <a:ext uri="{9D8B030D-6E8A-4147-A177-3AD203B41FA5}">
                      <a16:colId xmlns:a16="http://schemas.microsoft.com/office/drawing/2014/main" val="4172704202"/>
                    </a:ext>
                  </a:extLst>
                </a:gridCol>
                <a:gridCol w="5781990">
                  <a:extLst>
                    <a:ext uri="{9D8B030D-6E8A-4147-A177-3AD203B41FA5}">
                      <a16:colId xmlns:a16="http://schemas.microsoft.com/office/drawing/2014/main" val="3414178931"/>
                    </a:ext>
                  </a:extLst>
                </a:gridCol>
              </a:tblGrid>
              <a:tr h="63229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>
                          <a:effectLst/>
                        </a:rPr>
                        <a:t>Family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 err="1">
                          <a:effectLst/>
                        </a:rPr>
                        <a:t>Sequence</a:t>
                      </a:r>
                      <a:r>
                        <a:rPr lang="da-DK" sz="1600" dirty="0">
                          <a:effectLst/>
                        </a:rPr>
                        <a:t> variant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>
                          <a:effectLst/>
                        </a:rPr>
                        <a:t>(</a:t>
                      </a:r>
                      <a:r>
                        <a:rPr lang="da-DK" sz="1600" dirty="0" err="1">
                          <a:effectLst/>
                        </a:rPr>
                        <a:t>homozygous</a:t>
                      </a:r>
                      <a:r>
                        <a:rPr lang="da-DK" sz="1600" dirty="0">
                          <a:effectLst/>
                        </a:rPr>
                        <a:t>)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>
                          <a:effectLst/>
                        </a:rPr>
                        <a:t>Protein </a:t>
                      </a:r>
                      <a:r>
                        <a:rPr lang="da-DK" sz="1600" dirty="0" err="1">
                          <a:effectLst/>
                        </a:rPr>
                        <a:t>change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 err="1">
                          <a:effectLst/>
                        </a:rPr>
                        <a:t>Phenotype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11153469"/>
                  </a:ext>
                </a:extLst>
              </a:tr>
              <a:tr h="103064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>
                          <a:effectLst/>
                        </a:rPr>
                        <a:t>1 and 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>
                          <a:effectLst/>
                        </a:rPr>
                        <a:t>c.216C&gt;G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>
                          <a:effectLst/>
                        </a:rPr>
                        <a:t>p.(Cys72Trp)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A 9-year-old Turkish girl and her 11-year-old first cousin both with ARPKD. </a:t>
                      </a:r>
                    </a:p>
                    <a:p>
                      <a:pPr algn="l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 same variant was identified in an 8-year-old Turkish boy with ARPKD. </a:t>
                      </a:r>
                    </a:p>
                    <a:p>
                      <a:pPr algn="l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of them have liver involvement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54752250"/>
                  </a:ext>
                </a:extLst>
              </a:tr>
              <a:tr h="59741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>
                          <a:effectLst/>
                        </a:rPr>
                        <a:t>3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>
                          <a:effectLst/>
                        </a:rPr>
                        <a:t>c.193T&gt;C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da-DK" sz="1600" dirty="0">
                          <a:effectLst/>
                        </a:rPr>
                        <a:t>p.(Cys65Arg)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A 5-year-old boy from Sri Lanka with ARPKD and no liver involvement</a:t>
                      </a:r>
                      <a:endParaRPr lang="da-DK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596013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49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2-01-12T10:58:03Z</dcterms:modified>
</cp:coreProperties>
</file>